
<file path=[Content_Types].xml><?xml version="1.0" encoding="utf-8"?>
<Types xmlns="http://schemas.openxmlformats.org/package/2006/content-types"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7199313" cy="40679688"/>
  <p:notesSz cx="6858000" cy="9144000"/>
  <p:defaultTextStyle>
    <a:defPPr>
      <a:defRPr lang="es-AR"/>
    </a:defPPr>
    <a:lvl1pPr marL="0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1pPr>
    <a:lvl2pPr marL="1641413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2pPr>
    <a:lvl3pPr marL="3282825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3pPr>
    <a:lvl4pPr marL="4924238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4pPr>
    <a:lvl5pPr marL="6565650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5pPr>
    <a:lvl6pPr marL="8207063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6pPr>
    <a:lvl7pPr marL="9848475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7pPr>
    <a:lvl8pPr marL="11489888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8pPr>
    <a:lvl9pPr marL="13131300" algn="l" defTabSz="3282825" rtl="0" eaLnBrk="1" latinLnBrk="0" hangingPunct="1">
      <a:defRPr sz="646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813" userDrawn="1">
          <p15:clr>
            <a:srgbClr val="A4A3A4"/>
          </p15:clr>
        </p15:guide>
        <p15:guide id="2" pos="22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>
        <p:scale>
          <a:sx n="10" d="100"/>
          <a:sy n="10" d="100"/>
        </p:scale>
        <p:origin x="3204" y="444"/>
      </p:cViewPr>
      <p:guideLst>
        <p:guide orient="horz" pos="12813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6657535"/>
            <a:ext cx="6119416" cy="14162558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1366256"/>
            <a:ext cx="5399485" cy="9821505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781727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282527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2165817"/>
            <a:ext cx="1552352" cy="3447415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165817"/>
            <a:ext cx="4567064" cy="3447415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293048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852370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0141684"/>
            <a:ext cx="6209407" cy="1692161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27223386"/>
            <a:ext cx="6209407" cy="8898679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39655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0829084"/>
            <a:ext cx="3059708" cy="258108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0829084"/>
            <a:ext cx="3059708" cy="258108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959128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165826"/>
            <a:ext cx="6209407" cy="7862859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9972176"/>
            <a:ext cx="3045646" cy="4887210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4859386"/>
            <a:ext cx="3045646" cy="21855919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9972176"/>
            <a:ext cx="3060646" cy="4887210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4859386"/>
            <a:ext cx="3060646" cy="21855919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43310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126887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024897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2711979"/>
            <a:ext cx="2321966" cy="9491927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5857131"/>
            <a:ext cx="3644652" cy="28908945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2203907"/>
            <a:ext cx="2321966" cy="2260924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37930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2711979"/>
            <a:ext cx="2321966" cy="9491927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5857131"/>
            <a:ext cx="3644652" cy="28908945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2203907"/>
            <a:ext cx="2321966" cy="2260924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102022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165826"/>
            <a:ext cx="6209407" cy="78628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0829084"/>
            <a:ext cx="6209407" cy="258108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37704053"/>
            <a:ext cx="1619845" cy="21658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0B992-9018-4E51-8507-78D3914865D1}" type="datetimeFigureOut">
              <a:rPr lang="es-AR" smtClean="0"/>
              <a:t>01/12/2021</a:t>
            </a:fld>
            <a:endParaRPr lang="es-A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37704053"/>
            <a:ext cx="2429768" cy="21658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37704053"/>
            <a:ext cx="1619845" cy="21658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78101-1B8F-4298-9EBB-E6FC4781F931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675076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Relationship Id="rId9" Type="http://schemas.openxmlformats.org/officeDocument/2006/relationships/image" Target="../media/image8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508820" y="73744"/>
            <a:ext cx="6675745" cy="40590952"/>
            <a:chOff x="508820" y="73744"/>
            <a:chExt cx="6675745" cy="40590952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/>
            <a:srcRect b="571"/>
            <a:stretch/>
          </p:blipFill>
          <p:spPr>
            <a:xfrm>
              <a:off x="613323" y="296693"/>
              <a:ext cx="3754034" cy="5428894"/>
            </a:xfrm>
            <a:prstGeom prst="rect">
              <a:avLst/>
            </a:prstGeom>
          </p:spPr>
        </p:pic>
        <p:sp>
          <p:nvSpPr>
            <p:cNvPr id="5" name="CuadroTexto 4"/>
            <p:cNvSpPr txBox="1"/>
            <p:nvPr/>
          </p:nvSpPr>
          <p:spPr>
            <a:xfrm>
              <a:off x="2094169" y="391046"/>
              <a:ext cx="1827744" cy="2505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14" b="1" i="1" dirty="0" err="1"/>
                <a:t>Xba</a:t>
              </a:r>
              <a:r>
                <a:rPr lang="en-US" sz="514" b="1" dirty="0" err="1"/>
                <a:t>I</a:t>
              </a:r>
              <a:r>
                <a:rPr lang="en-US" sz="514" b="1" dirty="0"/>
                <a:t>-pattern              Cluster </a:t>
              </a:r>
              <a:r>
                <a:rPr lang="en-US" sz="514" b="1" dirty="0" smtClean="0"/>
                <a:t>No</a:t>
              </a:r>
              <a:r>
                <a:rPr lang="en-US" sz="514" b="1" dirty="0"/>
                <a:t>.                Outbreak </a:t>
              </a:r>
              <a:r>
                <a:rPr lang="en-US" sz="514" b="1" dirty="0" smtClean="0"/>
                <a:t>No</a:t>
              </a:r>
              <a:r>
                <a:rPr lang="en-US" sz="514" b="1" dirty="0"/>
                <a:t>.- type  </a:t>
              </a:r>
            </a:p>
            <a:p>
              <a:r>
                <a:rPr lang="en-US" sz="514" b="1" dirty="0"/>
                <a:t>                             </a:t>
              </a:r>
              <a:r>
                <a:rPr lang="en-US" sz="514" b="1" dirty="0" smtClean="0"/>
                <a:t>    (number of strains*)    (number of strains*)</a:t>
              </a:r>
              <a:endParaRPr lang="en-US" sz="514" b="1" dirty="0"/>
            </a:p>
          </p:txBody>
        </p:sp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3"/>
            <a:srcRect t="2631" b="2737"/>
            <a:stretch/>
          </p:blipFill>
          <p:spPr>
            <a:xfrm>
              <a:off x="617745" y="5715135"/>
              <a:ext cx="3751434" cy="5164359"/>
            </a:xfrm>
            <a:prstGeom prst="rect">
              <a:avLst/>
            </a:prstGeom>
          </p:spPr>
        </p:pic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4"/>
            <a:srcRect t="886" b="2587"/>
            <a:stretch/>
          </p:blipFill>
          <p:spPr>
            <a:xfrm>
              <a:off x="615704" y="10873743"/>
              <a:ext cx="3751434" cy="5267708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5"/>
            <a:srcRect t="842" b="3022"/>
            <a:stretch/>
          </p:blipFill>
          <p:spPr>
            <a:xfrm>
              <a:off x="615704" y="16135701"/>
              <a:ext cx="3751434" cy="5246378"/>
            </a:xfrm>
            <a:prstGeom prst="rect">
              <a:avLst/>
            </a:prstGeom>
          </p:spPr>
        </p:pic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6"/>
            <a:srcRect t="662" b="1260"/>
            <a:stretch/>
          </p:blipFill>
          <p:spPr>
            <a:xfrm>
              <a:off x="615704" y="21380405"/>
              <a:ext cx="3751434" cy="5352348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7"/>
            <a:srcRect t="2631" b="3044"/>
            <a:stretch/>
          </p:blipFill>
          <p:spPr>
            <a:xfrm>
              <a:off x="615704" y="26732750"/>
              <a:ext cx="3751434" cy="5147537"/>
            </a:xfrm>
            <a:prstGeom prst="rect">
              <a:avLst/>
            </a:prstGeom>
          </p:spPr>
        </p:pic>
        <p:pic>
          <p:nvPicPr>
            <p:cNvPr id="10" name="Imagen 9"/>
            <p:cNvPicPr>
              <a:picLocks noChangeAspect="1"/>
            </p:cNvPicPr>
            <p:nvPr/>
          </p:nvPicPr>
          <p:blipFill rotWithShape="1">
            <a:blip r:embed="rId8"/>
            <a:srcRect t="362" b="888"/>
            <a:stretch/>
          </p:blipFill>
          <p:spPr>
            <a:xfrm>
              <a:off x="615704" y="31880287"/>
              <a:ext cx="3751434" cy="5389050"/>
            </a:xfrm>
            <a:prstGeom prst="rect">
              <a:avLst/>
            </a:prstGeom>
          </p:spPr>
        </p:pic>
        <p:pic>
          <p:nvPicPr>
            <p:cNvPr id="11" name="Imagen 10"/>
            <p:cNvPicPr>
              <a:picLocks noChangeAspect="1"/>
            </p:cNvPicPr>
            <p:nvPr/>
          </p:nvPicPr>
          <p:blipFill rotWithShape="1">
            <a:blip r:embed="rId9"/>
            <a:srcRect t="3750"/>
            <a:stretch/>
          </p:blipFill>
          <p:spPr>
            <a:xfrm>
              <a:off x="618350" y="37264314"/>
              <a:ext cx="3750952" cy="3400382"/>
            </a:xfrm>
            <a:prstGeom prst="rect">
              <a:avLst/>
            </a:prstGeom>
          </p:spPr>
        </p:pic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3A12B476-A23F-40A7-8E11-FCE071091891}"/>
                </a:ext>
              </a:extLst>
            </p:cNvPr>
            <p:cNvSpPr txBox="1"/>
            <p:nvPr/>
          </p:nvSpPr>
          <p:spPr>
            <a:xfrm>
              <a:off x="508820" y="73744"/>
              <a:ext cx="66757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Supplementary material. Figure </a:t>
              </a:r>
              <a:r>
                <a:rPr lang="en-US" sz="1100" b="1" dirty="0" smtClean="0"/>
                <a:t>S1. </a:t>
              </a:r>
              <a:r>
                <a:rPr lang="en-US" sz="1100" b="1" dirty="0" err="1" smtClean="0"/>
                <a:t>Dendrogram</a:t>
              </a:r>
              <a:r>
                <a:rPr lang="en-US" sz="1100" b="1" dirty="0" smtClean="0"/>
                <a:t> of STEC O145 representative strains of each pattern. </a:t>
              </a:r>
              <a:endParaRPr lang="en-US" sz="1100" b="1" dirty="0"/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4089400" y="830179"/>
              <a:ext cx="2851150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71450" indent="-171450" algn="just">
                <a:buFont typeface="Arial" panose="020B0604020202020204" pitchFamily="34" charset="0"/>
                <a:buChar char="•"/>
              </a:pPr>
              <a:r>
                <a:rPr lang="en-US" sz="1100" b="1" dirty="0" smtClean="0"/>
                <a:t>The </a:t>
              </a:r>
              <a:r>
                <a:rPr lang="en-US" sz="1100" b="1" dirty="0" err="1" smtClean="0"/>
                <a:t>dendrogram</a:t>
              </a:r>
              <a:r>
                <a:rPr lang="en-US" sz="1100" b="1" dirty="0" smtClean="0"/>
                <a:t> include a representative strain of each pattern.</a:t>
              </a:r>
            </a:p>
            <a:p>
              <a:pPr marL="171450" indent="-171450" algn="just">
                <a:buFont typeface="Arial" panose="020B0604020202020204" pitchFamily="34" charset="0"/>
                <a:buChar char="•"/>
              </a:pPr>
              <a:r>
                <a:rPr lang="en-US" sz="1100" b="1" dirty="0" smtClean="0"/>
                <a:t>The clusters No. and outbreaks No. are indicated associated to the pattern, if any.</a:t>
              </a:r>
            </a:p>
            <a:p>
              <a:pPr marL="171450" indent="-171450" algn="just">
                <a:buFont typeface="Arial" panose="020B0604020202020204" pitchFamily="34" charset="0"/>
                <a:buChar char="•"/>
              </a:pPr>
              <a:r>
                <a:rPr lang="en-US" sz="1100" b="1" dirty="0" smtClean="0"/>
                <a:t>*Number of the strains included in clusters and/or associated to outbreaks</a:t>
              </a:r>
              <a:endParaRPr lang="en-US" sz="1100" b="1" dirty="0"/>
            </a:p>
          </p:txBody>
        </p:sp>
        <p:sp>
          <p:nvSpPr>
            <p:cNvPr id="15" name="Rectángulo 14"/>
            <p:cNvSpPr/>
            <p:nvPr/>
          </p:nvSpPr>
          <p:spPr>
            <a:xfrm>
              <a:off x="4089401" y="757993"/>
              <a:ext cx="2933700" cy="131210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8625233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</TotalTime>
  <Words>75</Words>
  <Application>Microsoft Office PowerPoint</Application>
  <PresentationFormat>Personalizado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olina CARBONARI</dc:creator>
  <cp:lastModifiedBy>Windows User</cp:lastModifiedBy>
  <cp:revision>21</cp:revision>
  <cp:lastPrinted>2021-11-21T20:32:27Z</cp:lastPrinted>
  <dcterms:created xsi:type="dcterms:W3CDTF">2021-11-17T22:00:30Z</dcterms:created>
  <dcterms:modified xsi:type="dcterms:W3CDTF">2021-12-02T02:48:13Z</dcterms:modified>
</cp:coreProperties>
</file>